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66" d="100"/>
          <a:sy n="66" d="100"/>
        </p:scale>
        <p:origin x="600" y="1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5559155-0627-28BB-D225-D39486ACB37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239CF68A-E5C2-7FEF-6035-1462D40FAC3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606A6A4-D36D-774D-772A-1AA8480477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3B7F3-00F2-4A0D-88E9-33B30857F1A7}" type="datetimeFigureOut">
              <a:rPr lang="de-DE" smtClean="0"/>
              <a:t>07.03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2B4E985-13B0-98F2-5721-0B203DF34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41F6894-164B-61AC-6EE2-CDB8ED31FB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0C026-C68E-43EE-A8B7-9000AC9363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88182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D199D80-06A4-CB2A-0407-813FE97BB1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03E976B-9AB1-03FE-A5D2-3DD97B95B4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5304E2F-6BD5-8E2E-6CA5-EFF55E410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3B7F3-00F2-4A0D-88E9-33B30857F1A7}" type="datetimeFigureOut">
              <a:rPr lang="de-DE" smtClean="0"/>
              <a:t>07.03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5CF2823-3DEC-63C8-6677-1E5BD195AC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7338767-7FAF-76CE-298D-66CF7E4D64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0C026-C68E-43EE-A8B7-9000AC9363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07222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1FCB133D-9363-4123-5707-F71494D2D76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915CB518-5F37-AC17-950B-BCDB252393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9D7A050-2795-75BC-1855-C6728CFCF3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3B7F3-00F2-4A0D-88E9-33B30857F1A7}" type="datetimeFigureOut">
              <a:rPr lang="de-DE" smtClean="0"/>
              <a:t>07.03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39BB95D-A55F-DC3F-7118-5DFE729F0A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CD245DE-AA96-EEC4-20B3-F82F085BB9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0C026-C68E-43EE-A8B7-9000AC9363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94338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2D6A1E6-2802-3F65-4C9A-D1D852C6D4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1F2C1EC-F7B6-E0BF-E2A2-F23DAD926E4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CE1E184-BA94-8E05-2A52-DCA72C3A35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3B7F3-00F2-4A0D-88E9-33B30857F1A7}" type="datetimeFigureOut">
              <a:rPr lang="de-DE" smtClean="0"/>
              <a:t>07.03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1E3B70D-670A-E6AD-E190-25F96C1594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114B6C8-85E0-C817-5F9E-049AEDA8AF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0C026-C68E-43EE-A8B7-9000AC9363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754811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A0424DB-97E5-D4C2-D4D3-3EC795D994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92FA383-F09B-3283-4A9B-AAEB14A395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0E6B7CA-18CD-4EBF-B99C-9C8D0D72EE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3B7F3-00F2-4A0D-88E9-33B30857F1A7}" type="datetimeFigureOut">
              <a:rPr lang="de-DE" smtClean="0"/>
              <a:t>07.03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0F0CDDF-39AA-D93A-4298-4577A4FAE9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4CC2028-8182-B70C-BBF7-5889436A14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0C026-C68E-43EE-A8B7-9000AC9363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7121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74A2082-FEED-4D43-93E3-6EBF364D51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2D84B0D-27E1-C0F7-E91B-20A3637706D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0E8F5D5E-5E91-C694-AB43-244F82B50A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0FC6AB0-AC15-96BB-BD42-661EB6EF41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3B7F3-00F2-4A0D-88E9-33B30857F1A7}" type="datetimeFigureOut">
              <a:rPr lang="de-DE" smtClean="0"/>
              <a:t>07.03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100DF71-9D11-430E-D330-C0BF7B8A4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71A2757-C12F-CADA-A477-BE4A8E3535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0C026-C68E-43EE-A8B7-9000AC9363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981499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875A6E2-3518-5017-EDA1-3458AC28FB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EED37B6-933C-0AC0-CBDC-0955438A44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4A60E948-1A49-0DED-6F43-F884569212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BDD5102A-262D-E3D0-1F35-65D655D329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1EB82482-C468-A88C-4EEA-1F033E8E06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B378A0AC-0489-BBD2-255B-28777E695C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3B7F3-00F2-4A0D-88E9-33B30857F1A7}" type="datetimeFigureOut">
              <a:rPr lang="de-DE" smtClean="0"/>
              <a:t>07.03.2026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47CF419A-5ED8-A24A-D528-6B4E4B88D9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D0FB7C43-250D-B0EA-C0E1-0D629B0BF1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0C026-C68E-43EE-A8B7-9000AC9363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15208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57C0230-0DA8-4147-8559-29786E3E50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8D584F7D-08B0-1869-64BA-C18F31EF3C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3B7F3-00F2-4A0D-88E9-33B30857F1A7}" type="datetimeFigureOut">
              <a:rPr lang="de-DE" smtClean="0"/>
              <a:t>07.03.2026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D09845D2-6EE1-5CFF-A40E-0CC30BA64B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506B134B-B85F-9B59-8D6C-5A85122D45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0C026-C68E-43EE-A8B7-9000AC9363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67038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56B84DFC-6D14-4B29-41BB-3FE25FA059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3B7F3-00F2-4A0D-88E9-33B30857F1A7}" type="datetimeFigureOut">
              <a:rPr lang="de-DE" smtClean="0"/>
              <a:t>07.03.2026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2C0890B9-F06A-EF07-8B0C-25C3A49B48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B7F4859B-0B1C-AE45-D168-B80B065AB5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0C026-C68E-43EE-A8B7-9000AC9363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41704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79C3FA3-4FC8-16E5-FBE1-D1754B7596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1AB4F59-0069-B7D5-9170-3317E065A67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EEA24A6C-F3A1-7272-6A13-35A6EFC3A6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B3A1136-BF2A-CA5F-B090-1C67520D09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3B7F3-00F2-4A0D-88E9-33B30857F1A7}" type="datetimeFigureOut">
              <a:rPr lang="de-DE" smtClean="0"/>
              <a:t>07.03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422ABE6-81B0-EE61-2199-421D9AA209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2654F93-C602-4142-B5A7-BF6A11C01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0C026-C68E-43EE-A8B7-9000AC9363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77936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117A20F-9E3C-386C-325D-7E12F58420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EA1A7D4C-D11F-09CB-3368-1B493D86F3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47F1491-73C4-0355-5AA7-8DD59B134D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6FF809C-A7B9-0256-05CB-C67D6D5BE0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3B7F3-00F2-4A0D-88E9-33B30857F1A7}" type="datetimeFigureOut">
              <a:rPr lang="de-DE" smtClean="0"/>
              <a:t>07.03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7668DC51-6D38-58A4-82B9-EE13D2F27B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E81C87B-4FBC-9DC1-4F20-C13E5B205E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B0C026-C68E-43EE-A8B7-9000AC9363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09617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C936D988-7738-E55F-E408-2DDA7AF778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86B39B5-B301-E96B-102E-377A00FD4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5707BDA-C027-98D4-BF5F-9D4F29463D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323B7F3-00F2-4A0D-88E9-33B30857F1A7}" type="datetimeFigureOut">
              <a:rPr lang="de-DE" smtClean="0"/>
              <a:t>07.03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99932D9-F579-98D5-BA91-F83B86C7803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8EB461D-97B9-C056-8C03-299ADC76F1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BB0C026-C68E-43EE-A8B7-9000AC9363E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10852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>
            <a:extLst>
              <a:ext uri="{FF2B5EF4-FFF2-40B4-BE49-F238E27FC236}">
                <a16:creationId xmlns:a16="http://schemas.microsoft.com/office/drawing/2014/main" id="{EA80E5C3-0AFA-5373-B977-D1F7E6999624}"/>
              </a:ext>
            </a:extLst>
          </p:cNvPr>
          <p:cNvSpPr txBox="1"/>
          <p:nvPr/>
        </p:nvSpPr>
        <p:spPr>
          <a:xfrm>
            <a:off x="2726606" y="833718"/>
            <a:ext cx="679391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600" b="1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1600" b="1">
                <a:latin typeface="Arial" panose="020B0604020202020204" pitchFamily="34" charset="0"/>
                <a:cs typeface="Arial" panose="020B0604020202020204" pitchFamily="34" charset="0"/>
              </a:rPr>
              <a:t>Ct, </a:t>
            </a:r>
            <a:r>
              <a:rPr lang="de-DE" sz="1600" b="1">
                <a:latin typeface="Symbol" panose="05050102010706020507" pitchFamily="18" charset="2"/>
                <a:cs typeface="Arial" panose="020B0604020202020204" pitchFamily="34" charset="0"/>
              </a:rPr>
              <a:t>DD</a:t>
            </a:r>
            <a:r>
              <a:rPr lang="de-DE" sz="1600" b="1">
                <a:latin typeface="Arial" panose="020B0604020202020204" pitchFamily="34" charset="0"/>
                <a:cs typeface="Arial" panose="020B0604020202020204" pitchFamily="34" charset="0"/>
              </a:rPr>
              <a:t>Ct, 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>
                <a:latin typeface="Arial" panose="020B0604020202020204" pitchFamily="34" charset="0"/>
                <a:cs typeface="Arial" panose="020B0604020202020204" pitchFamily="34" charset="0"/>
              </a:rPr>
              <a:t>and adjacent</a:t>
            </a:r>
            <a:r>
              <a:rPr lang="en-GB" sz="16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600" b="1">
                <a:latin typeface="Arial" panose="020B0604020202020204" pitchFamily="34" charset="0"/>
                <a:cs typeface="Arial" panose="020B0604020202020204" pitchFamily="34" charset="0"/>
              </a:rPr>
              <a:t>non-tumor</a:t>
            </a:r>
            <a:r>
              <a:rPr lang="en-GB" sz="16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40AD1044-9150-7814-72A6-5C1C17370F8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390160"/>
              </p:ext>
            </p:extLst>
          </p:nvPr>
        </p:nvGraphicFramePr>
        <p:xfrm>
          <a:off x="322202" y="1344709"/>
          <a:ext cx="11616358" cy="437480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46783">
                  <a:extLst>
                    <a:ext uri="{9D8B030D-6E8A-4147-A177-3AD203B41FA5}">
                      <a16:colId xmlns:a16="http://schemas.microsoft.com/office/drawing/2014/main" val="3059630943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1546088647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3269087303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1579492419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3928189890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3461473749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1019555149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179984608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3949697345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1249569447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2236424786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2714558505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4021996457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2732458832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4186697585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4158335370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1376020691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917508971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3896528487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1131764238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791109707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1601372576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214372637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1111137991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707240060"/>
                    </a:ext>
                  </a:extLst>
                </a:gridCol>
                <a:gridCol w="446783">
                  <a:extLst>
                    <a:ext uri="{9D8B030D-6E8A-4147-A177-3AD203B41FA5}">
                      <a16:colId xmlns:a16="http://schemas.microsoft.com/office/drawing/2014/main" val="3381182157"/>
                    </a:ext>
                  </a:extLst>
                </a:gridCol>
              </a:tblGrid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Patient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Tumor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138</a:t>
                      </a:r>
                      <a:r>
                        <a:rPr lang="de-DE" sz="400" b="1" u="none" strike="noStrike">
                          <a:effectLst/>
                          <a:latin typeface="Symbol" panose="05050102010706020507" pitchFamily="18" charset="2"/>
                          <a:cs typeface="Arial" panose="020B0604020202020204" pitchFamily="34" charset="0"/>
                        </a:rPr>
                        <a:t>D</a:t>
                      </a: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 tum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</a:t>
                      </a:r>
                      <a:r>
                        <a:rPr lang="de-DE" sz="400" b="1" u="none" strike="noStrike">
                          <a:effectLst/>
                        </a:rPr>
                        <a:t>138</a:t>
                      </a:r>
                      <a:r>
                        <a:rPr lang="de-DE" sz="400" b="1" u="none" strike="noStrike"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de-DE" sz="400" b="1" u="none" strike="noStrike">
                          <a:effectLst/>
                        </a:rPr>
                        <a:t>Ct adj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</a:t>
                      </a:r>
                      <a:r>
                        <a:rPr lang="de-DE" sz="400" b="1" u="none" strike="noStrike">
                          <a:effectLst/>
                        </a:rPr>
                        <a:t>181</a:t>
                      </a:r>
                      <a:r>
                        <a:rPr lang="de-DE" sz="400" b="1" u="none" strike="noStrike"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de-DE" sz="400" b="1" u="none" strike="noStrike">
                          <a:effectLst/>
                        </a:rPr>
                        <a:t>Ct tum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</a:t>
                      </a:r>
                      <a:r>
                        <a:rPr lang="de-DE" sz="400" b="1" u="none" strike="noStrike">
                          <a:effectLst/>
                        </a:rPr>
                        <a:t>181</a:t>
                      </a:r>
                      <a:r>
                        <a:rPr lang="de-DE" sz="400" b="1" u="none" strike="noStrike"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de-DE" sz="400" b="1" u="none" strike="noStrike">
                          <a:effectLst/>
                        </a:rPr>
                        <a:t>Ct adj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</a:t>
                      </a:r>
                      <a:r>
                        <a:rPr lang="de-DE" sz="400" b="1" u="none" strike="noStrike">
                          <a:effectLst/>
                        </a:rPr>
                        <a:t>143</a:t>
                      </a:r>
                      <a:r>
                        <a:rPr lang="de-DE" sz="400" b="1" u="none" strike="noStrike"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de-DE" sz="400" b="1" u="none" strike="noStrike">
                          <a:effectLst/>
                        </a:rPr>
                        <a:t>Ct tum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</a:t>
                      </a:r>
                      <a:r>
                        <a:rPr lang="de-DE" sz="400" b="1" u="none" strike="noStrike">
                          <a:effectLst/>
                        </a:rPr>
                        <a:t>143</a:t>
                      </a:r>
                      <a:r>
                        <a:rPr lang="de-DE" sz="400" b="1" u="none" strike="noStrike"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de-DE" sz="400" b="1" u="none" strike="noStrike">
                          <a:effectLst/>
                        </a:rPr>
                        <a:t>Ct adj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</a:t>
                      </a:r>
                      <a:r>
                        <a:rPr lang="de-DE" sz="400" b="1" u="none" strike="noStrike">
                          <a:effectLst/>
                        </a:rPr>
                        <a:t>145</a:t>
                      </a:r>
                      <a:r>
                        <a:rPr lang="de-DE" sz="400" b="1" u="none" strike="noStrike"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de-DE" sz="400" b="1" u="none" strike="noStrike">
                          <a:effectLst/>
                        </a:rPr>
                        <a:t>Ct tum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</a:t>
                      </a:r>
                      <a:r>
                        <a:rPr lang="de-DE" sz="400" b="1" u="none" strike="noStrike">
                          <a:effectLst/>
                        </a:rPr>
                        <a:t>145</a:t>
                      </a:r>
                      <a:r>
                        <a:rPr lang="de-DE" sz="400" b="1" u="none" strike="noStrike">
                          <a:effectLst/>
                          <a:latin typeface="Symbol" panose="05050102010706020507" pitchFamily="18" charset="2"/>
                        </a:rPr>
                        <a:t>D</a:t>
                      </a:r>
                      <a:r>
                        <a:rPr lang="de-DE" sz="400" b="1" u="none" strike="noStrike">
                          <a:effectLst/>
                        </a:rPr>
                        <a:t>Ct adj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</a:t>
                      </a:r>
                      <a:r>
                        <a:rPr lang="de-DE" sz="400" b="1" u="none" strike="noStrike">
                          <a:effectLst/>
                        </a:rPr>
                        <a:t>138</a:t>
                      </a:r>
                      <a:r>
                        <a:rPr lang="de-DE" sz="400" b="1" u="none" strike="noStrike">
                          <a:effectLst/>
                          <a:latin typeface="Symbol" panose="05050102010706020507" pitchFamily="18" charset="2"/>
                        </a:rPr>
                        <a:t>DD</a:t>
                      </a:r>
                      <a:r>
                        <a:rPr lang="de-DE" sz="400" b="1" u="none" strike="noStrike">
                          <a:effectLst/>
                        </a:rPr>
                        <a:t>Ct tum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</a:t>
                      </a:r>
                      <a:r>
                        <a:rPr lang="de-DE" sz="400" b="1" u="none" strike="noStrike">
                          <a:effectLst/>
                        </a:rPr>
                        <a:t>138</a:t>
                      </a:r>
                      <a:r>
                        <a:rPr lang="de-DE" sz="400" b="1" u="none" strike="noStrike">
                          <a:effectLst/>
                          <a:latin typeface="Symbol" panose="05050102010706020507" pitchFamily="18" charset="2"/>
                        </a:rPr>
                        <a:t>DD</a:t>
                      </a:r>
                      <a:r>
                        <a:rPr lang="de-DE" sz="400" b="1" u="none" strike="noStrike">
                          <a:effectLst/>
                        </a:rPr>
                        <a:t>Ct adj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</a:t>
                      </a:r>
                      <a:r>
                        <a:rPr lang="de-DE" sz="400" b="1" u="none" strike="noStrike">
                          <a:effectLst/>
                        </a:rPr>
                        <a:t>181</a:t>
                      </a:r>
                      <a:r>
                        <a:rPr lang="de-DE" sz="400" b="1" u="none" strike="noStrike">
                          <a:effectLst/>
                          <a:latin typeface="Symbol" panose="05050102010706020507" pitchFamily="18" charset="2"/>
                        </a:rPr>
                        <a:t>DD</a:t>
                      </a:r>
                      <a:r>
                        <a:rPr lang="de-DE" sz="400" b="1" u="none" strike="noStrike">
                          <a:effectLst/>
                        </a:rPr>
                        <a:t>Ct tum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</a:t>
                      </a:r>
                      <a:r>
                        <a:rPr lang="de-DE" sz="400" b="1" u="none" strike="noStrike">
                          <a:effectLst/>
                        </a:rPr>
                        <a:t>181</a:t>
                      </a:r>
                      <a:r>
                        <a:rPr lang="de-DE" sz="400" b="1" u="none" strike="noStrike">
                          <a:effectLst/>
                          <a:latin typeface="Symbol" panose="05050102010706020507" pitchFamily="18" charset="2"/>
                        </a:rPr>
                        <a:t>DD</a:t>
                      </a:r>
                      <a:r>
                        <a:rPr lang="de-DE" sz="400" b="1" u="none" strike="noStrike">
                          <a:effectLst/>
                        </a:rPr>
                        <a:t>Ct adj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</a:t>
                      </a:r>
                      <a:r>
                        <a:rPr lang="de-DE" sz="400" b="1" u="none" strike="noStrike">
                          <a:effectLst/>
                        </a:rPr>
                        <a:t>143</a:t>
                      </a:r>
                      <a:r>
                        <a:rPr lang="de-DE" sz="400" b="1" u="none" strike="noStrike">
                          <a:effectLst/>
                          <a:latin typeface="Symbol" panose="05050102010706020507" pitchFamily="18" charset="2"/>
                        </a:rPr>
                        <a:t>DD</a:t>
                      </a:r>
                      <a:r>
                        <a:rPr lang="de-DE" sz="400" b="1" u="none" strike="noStrike">
                          <a:effectLst/>
                        </a:rPr>
                        <a:t>Ct tum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</a:t>
                      </a:r>
                      <a:r>
                        <a:rPr lang="de-DE" sz="400" b="1" u="none" strike="noStrike">
                          <a:effectLst/>
                        </a:rPr>
                        <a:t>143</a:t>
                      </a:r>
                      <a:r>
                        <a:rPr lang="de-DE" sz="400" b="1" u="none" strike="noStrike">
                          <a:effectLst/>
                          <a:latin typeface="Symbol" panose="05050102010706020507" pitchFamily="18" charset="2"/>
                        </a:rPr>
                        <a:t>DD</a:t>
                      </a:r>
                      <a:r>
                        <a:rPr lang="de-DE" sz="400" b="1" u="none" strike="noStrike">
                          <a:effectLst/>
                        </a:rPr>
                        <a:t>Ct adj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</a:t>
                      </a:r>
                      <a:r>
                        <a:rPr lang="de-DE" sz="400" b="1" u="none" strike="noStrike">
                          <a:effectLst/>
                        </a:rPr>
                        <a:t>145</a:t>
                      </a:r>
                      <a:r>
                        <a:rPr lang="de-DE" sz="400" b="1" u="none" strike="noStrike">
                          <a:effectLst/>
                          <a:latin typeface="Symbol" panose="05050102010706020507" pitchFamily="18" charset="2"/>
                        </a:rPr>
                        <a:t>DD</a:t>
                      </a:r>
                      <a:r>
                        <a:rPr lang="de-DE" sz="400" b="1" u="none" strike="noStrike">
                          <a:effectLst/>
                        </a:rPr>
                        <a:t>Ct tum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</a:t>
                      </a:r>
                      <a:r>
                        <a:rPr lang="de-DE" sz="400" b="1" u="none" strike="noStrike">
                          <a:effectLst/>
                        </a:rPr>
                        <a:t>145</a:t>
                      </a:r>
                      <a:r>
                        <a:rPr lang="de-DE" sz="400" b="1" u="none" strike="noStrike">
                          <a:effectLst/>
                          <a:latin typeface="Symbol" panose="05050102010706020507" pitchFamily="18" charset="2"/>
                        </a:rPr>
                        <a:t>DD</a:t>
                      </a:r>
                      <a:r>
                        <a:rPr lang="de-DE" sz="400" b="1" u="none" strike="noStrike">
                          <a:effectLst/>
                        </a:rPr>
                        <a:t>Ct adj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</a:t>
                      </a:r>
                      <a:r>
                        <a:rPr lang="de-DE" sz="400" b="1" u="none" strike="noStrike">
                          <a:effectLst/>
                        </a:rPr>
                        <a:t>138 fold tum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</a:t>
                      </a:r>
                      <a:r>
                        <a:rPr lang="de-DE" sz="400" b="1" u="none" strike="noStrike">
                          <a:effectLst/>
                        </a:rPr>
                        <a:t>138 fold adj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</a:t>
                      </a:r>
                      <a:r>
                        <a:rPr lang="de-DE" sz="400" b="1" u="none" strike="noStrike">
                          <a:effectLst/>
                        </a:rPr>
                        <a:t>181 fold tum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</a:t>
                      </a:r>
                      <a:r>
                        <a:rPr lang="de-DE" sz="400" b="1" u="none" strike="noStrike">
                          <a:effectLst/>
                        </a:rPr>
                        <a:t>181 fold adj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</a:t>
                      </a:r>
                      <a:r>
                        <a:rPr lang="de-DE" sz="400" b="1" u="none" strike="noStrike">
                          <a:effectLst/>
                        </a:rPr>
                        <a:t>143 fold tum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</a:t>
                      </a:r>
                      <a:r>
                        <a:rPr lang="de-DE" sz="400" b="1" u="none" strike="noStrike">
                          <a:effectLst/>
                        </a:rPr>
                        <a:t>143 fold adj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</a:t>
                      </a:r>
                      <a:r>
                        <a:rPr lang="de-DE" sz="400" b="1" u="none" strike="noStrike">
                          <a:effectLst/>
                        </a:rPr>
                        <a:t>145 fold tum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4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-</a:t>
                      </a:r>
                      <a:r>
                        <a:rPr lang="de-DE" sz="400" b="1" u="none" strike="noStrike">
                          <a:effectLst/>
                        </a:rPr>
                        <a:t>145 fold adj</a:t>
                      </a:r>
                      <a:endParaRPr lang="de-DE" sz="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3221334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Enchondr01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7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8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1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8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9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5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68332815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Enchondr02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1,6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9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4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0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1,5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5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2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0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9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6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5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9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1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8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8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9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2976337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Enchondr03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7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1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3,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8,1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1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6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,2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,0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,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5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3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3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11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8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197484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Enchondr04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5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5,7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8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3,3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7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9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5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5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3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3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4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11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8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70990977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Enchondr05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5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4,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1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5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1,5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6,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5,9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7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3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3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0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5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7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1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7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2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3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4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6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1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8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02731968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Enchondr06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6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4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5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4,5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3,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0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7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4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6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5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3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5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11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7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8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5942733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Enchondr07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5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4,6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7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5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6,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4,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7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4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4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7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3,3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7,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6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7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38196274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Enchondr08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3,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2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0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6,2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4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7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0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7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5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6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3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11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8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92995166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Enchondr09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1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8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1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3,1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5,7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4,6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6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54,0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5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4,4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3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11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9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8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9890835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Enchondr10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6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3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1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4,5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6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4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,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6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7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3894415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Enchondr11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5,6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7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7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9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8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0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3,3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5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5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6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3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11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4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8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8543362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Enchondr12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1,2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5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1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3,7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7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2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5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3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11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2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8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60562738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Enchondr13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1,9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9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6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5,3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9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4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8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2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9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5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3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11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4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8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6515420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Enchondr14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1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5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5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4,8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7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7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7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5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9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3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11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8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69368826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Enchondr15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7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1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5,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9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5,7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3,7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5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4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7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8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2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1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3,0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1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5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6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6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6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2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5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55023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Enchondr16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1,7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3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4,0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5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1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2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5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9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3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11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8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5378634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0953483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101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9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6,0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2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3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5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1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3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45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70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37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74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9194918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102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1,9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0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3,6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6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8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45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9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70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37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74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24941190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103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9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3,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4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2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6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1,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7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7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4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6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1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9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5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3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1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5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9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1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21608904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104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5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6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0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6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3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6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45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2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70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37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74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59443749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105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3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4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1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8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4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3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0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9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7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2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3897518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106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8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8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,8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6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5,9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3,6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4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5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9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1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6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5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2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4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5,8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5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9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,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4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5,3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354529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107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1,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3,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3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2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,8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6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7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4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8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4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6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4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6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4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3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5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1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1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6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7464438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108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5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3,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5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6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1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4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6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6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6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4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6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3,3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5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4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6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6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3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7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4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0764960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109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0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9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4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,7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5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0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4,7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3,5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8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2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7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5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7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8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,7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,5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4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5551139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110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5,8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8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5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5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5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1,7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7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1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0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1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9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7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8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1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0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0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9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5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3018932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111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5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,1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2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8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1,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7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1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9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8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9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,1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6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4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9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9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6882240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7845583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201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8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,1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8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5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6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3,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1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1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91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0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16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0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3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5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767519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202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,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1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3,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1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6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4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5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,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91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16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3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0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1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5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6859845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203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5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5,7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2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5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2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5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3,8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6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5,1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6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8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,8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4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6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5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1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41709792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204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7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4,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3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3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4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4,5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3,1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4,3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6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5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0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8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8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4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3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1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0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871530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205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9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7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3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4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2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1,9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1,2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7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1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6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6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4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8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8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8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5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4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6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6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7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3611745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206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0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5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5,3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0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2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3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8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0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4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3,9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6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3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,8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3,2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7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7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7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5,1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6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7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20936698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207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3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5,7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3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3,3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1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6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6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5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,5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91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1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16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3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0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1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5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4773091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208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7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1,8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6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7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1,7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6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4,5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0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3,1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8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6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5,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5,4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7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7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5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6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9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3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4469733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209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7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5,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8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3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8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4,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2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1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4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4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0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1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,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7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8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3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22290832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210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5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5,8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3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8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4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1,4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5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4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5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1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4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8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7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1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4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5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76315010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55837205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301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6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9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0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4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7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,6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7,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3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6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4,3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9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,0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4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8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5,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1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0,7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9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0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5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6856923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302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3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2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,0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5,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9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5,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0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6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8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3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5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1,8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6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8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4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5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2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5,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8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5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3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7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1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4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3267968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303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4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5,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2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3,8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3,1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2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1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3,7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9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4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,8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4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2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38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2862057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304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3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4,1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5,8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1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1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5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2,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1,6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5,8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5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3,2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6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5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4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4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4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56,5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3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6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7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3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4005229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305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1,7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4,6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7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4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3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1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1,7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0,0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2,8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6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9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2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0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6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1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3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5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5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2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9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3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13325623"/>
                  </a:ext>
                </a:extLst>
              </a:tr>
              <a:tr h="9308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e-DE" sz="500" b="1" u="none" strike="noStrike">
                          <a:effectLst/>
                        </a:rPr>
                        <a:t>ChonsG306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3,7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3,9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8,1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7,5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9,8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6,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3,67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1,2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-0,1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3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5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1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9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7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2,4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0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1,1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3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6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9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1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5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19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de-DE" sz="500" u="none" strike="noStrike">
                          <a:effectLst/>
                        </a:rPr>
                        <a:t>0,4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722" marR="3722" marT="3722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8702066"/>
                  </a:ext>
                </a:extLst>
              </a:tr>
            </a:tbl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F70A6DEA-B4EE-5AD4-41B7-A1B478832609}"/>
              </a:ext>
            </a:extLst>
          </p:cNvPr>
          <p:cNvSpPr/>
          <p:nvPr/>
        </p:nvSpPr>
        <p:spPr>
          <a:xfrm>
            <a:off x="303152" y="1351059"/>
            <a:ext cx="11635408" cy="4374807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09528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42</Words>
  <Application>Microsoft Office PowerPoint</Application>
  <PresentationFormat>Widescreen</PresentationFormat>
  <Paragraphs>97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</vt:lpstr>
      <vt:lpstr>PowerPoint Presentation</vt:lpstr>
    </vt:vector>
  </TitlesOfParts>
  <Company>UKJ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chrenk, Karin</dc:creator>
  <cp:lastModifiedBy>Karin Schrenk</cp:lastModifiedBy>
  <cp:revision>9</cp:revision>
  <dcterms:created xsi:type="dcterms:W3CDTF">2026-02-17T10:44:16Z</dcterms:created>
  <dcterms:modified xsi:type="dcterms:W3CDTF">2026-03-07T18:07:13Z</dcterms:modified>
</cp:coreProperties>
</file>